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6"/>
  </p:notesMasterIdLst>
  <p:sldIdLst>
    <p:sldId id="352" r:id="rId2"/>
    <p:sldId id="347" r:id="rId3"/>
    <p:sldId id="342" r:id="rId4"/>
    <p:sldId id="351" r:id="rId5"/>
  </p:sldIdLst>
  <p:sldSz cx="17610138" cy="9906000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>
        <p15:guide id="1" orient="horz" pos="3108" userDrawn="1">
          <p15:clr>
            <a:srgbClr val="A4A3A4"/>
          </p15:clr>
        </p15:guide>
        <p15:guide id="2" pos="2121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009051"/>
    <a:srgbClr val="0432FF"/>
    <a:srgbClr val="FF0000"/>
    <a:srgbClr val="FF7C80"/>
    <a:srgbClr val="0033CC"/>
    <a:srgbClr val="00CC00"/>
    <a:srgbClr val="FFFF00"/>
    <a:srgbClr val="FF99FF"/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7" autoAdjust="0"/>
    <p:restoredTop sz="96327" autoAdjust="0"/>
  </p:normalViewPr>
  <p:slideViewPr>
    <p:cSldViewPr snapToGrid="0">
      <p:cViewPr varScale="1">
        <p:scale>
          <a:sx n="78" d="100"/>
          <a:sy n="78" d="100"/>
        </p:scale>
        <p:origin x="9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90" d="100"/>
          <a:sy n="90" d="100"/>
        </p:scale>
        <p:origin x="4232" y="200"/>
      </p:cViewPr>
      <p:guideLst>
        <p:guide orient="horz" pos="3108"/>
        <p:guide pos="212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obateru\Box%20Sync\&#23455;&#39443;\TT%20DHS\&#23455;&#39443;&#32080;&#26524;\20220524%20dhs%20speB%20pH%20tem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kobateru\Box%20Sync\&#23455;&#39443;\TT%20DHS\&#23455;&#39443;&#32080;&#26524;\20220524%20dhs%20speB%20pH%20tem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結果１ (2)'!$E$19:$E$28</c:f>
              <c:numCache>
                <c:formatCode>General</c:formatCode>
                <c:ptCount val="10"/>
                <c:pt idx="0">
                  <c:v>85</c:v>
                </c:pt>
                <c:pt idx="1">
                  <c:v>79</c:v>
                </c:pt>
                <c:pt idx="2">
                  <c:v>76</c:v>
                </c:pt>
                <c:pt idx="3">
                  <c:v>70</c:v>
                </c:pt>
                <c:pt idx="4">
                  <c:v>65</c:v>
                </c:pt>
                <c:pt idx="5">
                  <c:v>60</c:v>
                </c:pt>
                <c:pt idx="6">
                  <c:v>54</c:v>
                </c:pt>
                <c:pt idx="7">
                  <c:v>51</c:v>
                </c:pt>
                <c:pt idx="8">
                  <c:v>45</c:v>
                </c:pt>
                <c:pt idx="9">
                  <c:v>40</c:v>
                </c:pt>
              </c:numCache>
            </c:numRef>
          </c:xVal>
          <c:yVal>
            <c:numRef>
              <c:f>'結果１ (2)'!$F$19:$F$28</c:f>
              <c:numCache>
                <c:formatCode>0</c:formatCode>
                <c:ptCount val="10"/>
                <c:pt idx="0">
                  <c:v>5.0172334324569574</c:v>
                </c:pt>
                <c:pt idx="1">
                  <c:v>17.289340635524503</c:v>
                </c:pt>
                <c:pt idx="2">
                  <c:v>40.469236079822167</c:v>
                </c:pt>
                <c:pt idx="3">
                  <c:v>84.256373578602279</c:v>
                </c:pt>
                <c:pt idx="4">
                  <c:v>100</c:v>
                </c:pt>
                <c:pt idx="5">
                  <c:v>98.335938840867968</c:v>
                </c:pt>
                <c:pt idx="6">
                  <c:v>83.711590427925358</c:v>
                </c:pt>
                <c:pt idx="7">
                  <c:v>73.118609506138313</c:v>
                </c:pt>
                <c:pt idx="8">
                  <c:v>44.979958480018425</c:v>
                </c:pt>
                <c:pt idx="9">
                  <c:v>31.9869306862566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942-0647-80BB-CB33AD465E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813424320"/>
        <c:axId val="-1813433568"/>
      </c:scatterChart>
      <c:valAx>
        <c:axId val="-1813424320"/>
        <c:scaling>
          <c:orientation val="minMax"/>
          <c:max val="90"/>
          <c:min val="3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13433568"/>
        <c:crosses val="autoZero"/>
        <c:crossBetween val="midCat"/>
        <c:majorUnit val="5"/>
      </c:valAx>
      <c:valAx>
        <c:axId val="-1813433568"/>
        <c:scaling>
          <c:orientation val="minMax"/>
        </c:scaling>
        <c:delete val="0"/>
        <c:axPos val="l"/>
        <c:numFmt formatCode="0" sourceLinked="1"/>
        <c:majorTickMark val="in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13424320"/>
        <c:crosses val="autoZero"/>
        <c:crossBetween val="midCat"/>
      </c:valAx>
      <c:spPr>
        <a:noFill/>
        <a:ln w="50800">
          <a:solidFill>
            <a:schemeClr val="tx1"/>
          </a:solidFill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035187809864589"/>
          <c:y val="4.4244212962962964E-2"/>
          <c:w val="0.85910989927392578"/>
          <c:h val="0.85010300925925941"/>
        </c:manualLayout>
      </c:layout>
      <c:scatterChart>
        <c:scatterStyle val="lineMarker"/>
        <c:varyColors val="0"/>
        <c:ser>
          <c:idx val="0"/>
          <c:order val="0"/>
          <c:tx>
            <c:strRef>
              <c:f>'結果１ (2)'!$D$5</c:f>
              <c:strCache>
                <c:ptCount val="1"/>
                <c:pt idx="0">
                  <c:v>Phosphate buffer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結果１ (2)'!$C$6:$C$17</c:f>
              <c:numCache>
                <c:formatCode>General</c:formatCode>
                <c:ptCount val="12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  <c:pt idx="5">
                  <c:v>8</c:v>
                </c:pt>
                <c:pt idx="6">
                  <c:v>8.5</c:v>
                </c:pt>
                <c:pt idx="7">
                  <c:v>9</c:v>
                </c:pt>
                <c:pt idx="8">
                  <c:v>9</c:v>
                </c:pt>
                <c:pt idx="9">
                  <c:v>9.5</c:v>
                </c:pt>
                <c:pt idx="10">
                  <c:v>10</c:v>
                </c:pt>
                <c:pt idx="11">
                  <c:v>10.5</c:v>
                </c:pt>
              </c:numCache>
            </c:numRef>
          </c:xVal>
          <c:yVal>
            <c:numRef>
              <c:f>'結果１ (2)'!$D$6:$D$17</c:f>
              <c:numCache>
                <c:formatCode>0</c:formatCode>
                <c:ptCount val="12"/>
                <c:pt idx="0">
                  <c:v>26.317764795286713</c:v>
                </c:pt>
                <c:pt idx="1">
                  <c:v>61.281326605769678</c:v>
                </c:pt>
                <c:pt idx="2">
                  <c:v>85.961656917708979</c:v>
                </c:pt>
                <c:pt idx="3">
                  <c:v>78.475378772247566</c:v>
                </c:pt>
                <c:pt idx="4">
                  <c:v>59.09775059752975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F99-0F4C-93FF-BB1424CE40F5}"/>
            </c:ext>
          </c:extLst>
        </c:ser>
        <c:ser>
          <c:idx val="1"/>
          <c:order val="1"/>
          <c:tx>
            <c:strRef>
              <c:f>'結果１ (2)'!$E$5</c:f>
              <c:strCache>
                <c:ptCount val="1"/>
                <c:pt idx="0">
                  <c:v>Tris buffer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結果１ (2)'!$C$6:$C$17</c:f>
              <c:numCache>
                <c:formatCode>General</c:formatCode>
                <c:ptCount val="12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  <c:pt idx="5">
                  <c:v>8</c:v>
                </c:pt>
                <c:pt idx="6">
                  <c:v>8.5</c:v>
                </c:pt>
                <c:pt idx="7">
                  <c:v>9</c:v>
                </c:pt>
                <c:pt idx="8">
                  <c:v>9</c:v>
                </c:pt>
                <c:pt idx="9">
                  <c:v>9.5</c:v>
                </c:pt>
                <c:pt idx="10">
                  <c:v>10</c:v>
                </c:pt>
                <c:pt idx="11">
                  <c:v>10.5</c:v>
                </c:pt>
              </c:numCache>
            </c:numRef>
          </c:xVal>
          <c:yVal>
            <c:numRef>
              <c:f>'結果１ (2)'!$E$6:$E$17</c:f>
              <c:numCache>
                <c:formatCode>General</c:formatCode>
                <c:ptCount val="12"/>
                <c:pt idx="5" formatCode="0">
                  <c:v>84.82015518765806</c:v>
                </c:pt>
                <c:pt idx="6" formatCode="0">
                  <c:v>100.00000002650171</c:v>
                </c:pt>
                <c:pt idx="7" formatCode="0">
                  <c:v>74.22867735708462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F99-0F4C-93FF-BB1424CE40F5}"/>
            </c:ext>
          </c:extLst>
        </c:ser>
        <c:ser>
          <c:idx val="2"/>
          <c:order val="2"/>
          <c:tx>
            <c:strRef>
              <c:f>'結果１ (2)'!$F$5</c:f>
              <c:strCache>
                <c:ptCount val="1"/>
                <c:pt idx="0">
                  <c:v>Glycine buffer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1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結果１ (2)'!$C$6:$C$17</c:f>
              <c:numCache>
                <c:formatCode>General</c:formatCode>
                <c:ptCount val="12"/>
                <c:pt idx="0">
                  <c:v>6</c:v>
                </c:pt>
                <c:pt idx="1">
                  <c:v>6.5</c:v>
                </c:pt>
                <c:pt idx="2">
                  <c:v>7</c:v>
                </c:pt>
                <c:pt idx="3">
                  <c:v>7.5</c:v>
                </c:pt>
                <c:pt idx="4">
                  <c:v>8</c:v>
                </c:pt>
                <c:pt idx="5">
                  <c:v>8</c:v>
                </c:pt>
                <c:pt idx="6">
                  <c:v>8.5</c:v>
                </c:pt>
                <c:pt idx="7">
                  <c:v>9</c:v>
                </c:pt>
                <c:pt idx="8">
                  <c:v>9</c:v>
                </c:pt>
                <c:pt idx="9">
                  <c:v>9.5</c:v>
                </c:pt>
                <c:pt idx="10">
                  <c:v>10</c:v>
                </c:pt>
                <c:pt idx="11">
                  <c:v>10.5</c:v>
                </c:pt>
              </c:numCache>
            </c:numRef>
          </c:xVal>
          <c:yVal>
            <c:numRef>
              <c:f>'結果１ (2)'!$F$6:$F$17</c:f>
              <c:numCache>
                <c:formatCode>General</c:formatCode>
                <c:ptCount val="12"/>
                <c:pt idx="8" formatCode="0">
                  <c:v>93.56297694900411</c:v>
                </c:pt>
                <c:pt idx="9" formatCode="0">
                  <c:v>46.367053270730132</c:v>
                </c:pt>
                <c:pt idx="10" formatCode="0">
                  <c:v>13.717074237929419</c:v>
                </c:pt>
                <c:pt idx="11" formatCode="0">
                  <c:v>2.910059200454957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2F99-0F4C-93FF-BB1424CE40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813437376"/>
        <c:axId val="-1813423232"/>
      </c:scatterChart>
      <c:valAx>
        <c:axId val="-1813437376"/>
        <c:scaling>
          <c:orientation val="minMax"/>
          <c:max val="11"/>
          <c:min val="5.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13423232"/>
        <c:crosses val="autoZero"/>
        <c:crossBetween val="midCat"/>
        <c:majorUnit val="0.5"/>
      </c:valAx>
      <c:valAx>
        <c:axId val="-1813423232"/>
        <c:scaling>
          <c:orientation val="minMax"/>
        </c:scaling>
        <c:delete val="0"/>
        <c:axPos val="l"/>
        <c:numFmt formatCode="0" sourceLinked="1"/>
        <c:majorTickMark val="in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13437376"/>
        <c:crossesAt val="5"/>
        <c:crossBetween val="midCat"/>
      </c:valAx>
      <c:spPr>
        <a:noFill/>
        <a:ln w="50800">
          <a:solidFill>
            <a:schemeClr val="tx1"/>
          </a:solidFill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5CB0D2-E8D4-5243-898D-B97C3E3891A0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7988" y="1233488"/>
            <a:ext cx="591978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43EABB-3BCB-AA4C-B5A1-2697BC635C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770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43EABB-3BCB-AA4C-B5A1-2697BC635CD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6393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43EABB-3BCB-AA4C-B5A1-2697BC635CD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96028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b="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43EABB-3BCB-AA4C-B5A1-2697BC635CD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54195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D43EABB-3BCB-AA4C-B5A1-2697BC635CD6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949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556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882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6" y="527405"/>
            <a:ext cx="379718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8" y="527405"/>
            <a:ext cx="11171431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319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7863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7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35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8" y="2637014"/>
            <a:ext cx="7484309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761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527404"/>
            <a:ext cx="15188744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2" y="2428349"/>
            <a:ext cx="744991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2" y="3618444"/>
            <a:ext cx="7449912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4" y="2428349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4" y="3618444"/>
            <a:ext cx="7486602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107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7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930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3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3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3" y="2971802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88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3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3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3" y="2971802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010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7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3F673-AF0C-46D3-B75B-02EB14828589}" type="datetimeFigureOut">
              <a:rPr kumimoji="1" lang="ja-JP" altLang="en-US" smtClean="0"/>
              <a:t>2024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7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7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863A1-EE50-43E9-8A76-D71340700C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912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8D49057F-ED07-396B-45E4-C2C71076AC0F}"/>
              </a:ext>
            </a:extLst>
          </p:cNvPr>
          <p:cNvSpPr txBox="1"/>
          <p:nvPr/>
        </p:nvSpPr>
        <p:spPr>
          <a:xfrm>
            <a:off x="1364104" y="8197027"/>
            <a:ext cx="15140065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ja-JP" sz="1800" b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en-US" altLang="ja-JP" sz="18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</a:endParaRPr>
          </a:p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lignment of the amino acid sequences of DHS homolog from </a:t>
            </a:r>
            <a:r>
              <a:rPr lang="en-US" altLang="ja-JP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. thermophilu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(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, DHS from </a:t>
            </a:r>
            <a:r>
              <a:rPr lang="en-US" altLang="ja-JP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rabidopsis thaliana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(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tDH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, DHS from human (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sDH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, DHS and HSS from </a:t>
            </a:r>
            <a:r>
              <a:rPr lang="en-US" altLang="ja-JP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enecio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8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vernali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(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vDH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SvHSS1 and SvHSS2) and DHS-like HSS (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peY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 from </a:t>
            </a:r>
            <a:r>
              <a:rPr lang="en-US" altLang="ja-JP" sz="18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ylindrospermum</a:t>
            </a:r>
            <a:r>
              <a:rPr lang="en-US" altLang="ja-JP" sz="1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8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tagnale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(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sSpeY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.  The amino acid sequence homology of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to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tDH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sDH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vDHS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SvHSS1, SvHSS2 and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sSpeY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is 27%, 26%, 27%, 27%, 27% and 33% identity, respectively.  The conserved lysine residue critical for catalytic activity is labelled with the arrow.</a:t>
            </a:r>
            <a:r>
              <a:rPr lang="ja-JP" altLang="ja-JP">
                <a:effectLst/>
              </a:rPr>
              <a:t> </a:t>
            </a:r>
            <a:endParaRPr lang="ja-JP" altLang="en-US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xmlns="" id="{AD7CEFBC-A690-C5FE-0216-797E68DCFDD3}"/>
              </a:ext>
            </a:extLst>
          </p:cNvPr>
          <p:cNvGrpSpPr/>
          <p:nvPr/>
        </p:nvGrpSpPr>
        <p:grpSpPr>
          <a:xfrm>
            <a:off x="2528595" y="477842"/>
            <a:ext cx="12552947" cy="7633069"/>
            <a:chOff x="2512553" y="1152402"/>
            <a:chExt cx="12552947" cy="7633069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xmlns="" id="{7CA2177B-F547-9057-2172-35BE05DAB18F}"/>
                </a:ext>
              </a:extLst>
            </p:cNvPr>
            <p:cNvSpPr txBox="1"/>
            <p:nvPr/>
          </p:nvSpPr>
          <p:spPr>
            <a:xfrm>
              <a:off x="2512553" y="1152612"/>
              <a:ext cx="12552947" cy="763285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884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dm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----------------MQKKELLSTPVVPIDIK------AFDAGPILEAMGKTAFQARNLHRAA----EIYLRMLE---------------------DDCAVILTLAGSLVSAGQGLI-V	72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At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----MEDDRVFSSVHSTVFKESESLEGKCDKIEGYDFNQGVDYPKLMRSMLTTGFQASNLGEAIDVVNQMLDWRLADETTVAEDCSEEEKNPSFRESVKCKIFLGFTSNLVSSGVRDT-I	115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Hs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MEGSLER-EAPAGALAAVLKHSSTLPPESTQVRGYDFNRGVNYRALLEAFGTTGFQATNFGRAVQQVNAMIEKKLEPLSQDED--QHADLTQSRRPLTSCTIFLGYTSNLISSGIRET-I	116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MEESMKQASVMENLRSVVFKESESLEGTCAKIRGYDFNNGIDYSQILKSMVSTGFQASNLGDAIETVNQMLDWRLSHE-QVTEDCSQEEKNPTYRESIKCKIFLGFTSNLISSGVRDI-I	118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1      MAE--SNKEAIDSARSNVFKESESLEGTCAKIGGYDFNNGIDHSKLLKSMVSTGFQASNLGDAMIITNQMLDWRLSHD-EVPENCSEEEKK--NRESVKCKIFLGFTSNLISSGVRET-I	114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2      MAE--SNKEAIDSARSNVFKESESLEGTCAKIGGYDFNNGIDHSKLLKSMVSTGFQASNLGDAMIITNQMLEWRLSHD-EVPENCSEEEKK--NRESVKCKIFLGFTSNLISSGVRET-I	114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884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sSpeY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--------------MSKQQGQKITPTPMPTDIG------VVDL-------IDNYFTAYNSARLREICKLLSQEMLT---------------------EGVTVGVSLSGALTPAGFGVSAL	72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                        .  :      .:        .:          . * * *          :    *                          : :  :. *  :*     :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 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dm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HDLIRKGLVDVIVATGANIVDQDFFEALGHRHYQGDPRADDEALRRLWIDRIYDTYIDEEELRHTDYTVAEIADGL-EPRPYSSREFIWHMGRYLAE----RGLGEKSIVRAAYEEGVPI	187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At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RYLVQHHMVDVIVTTTGGVEEDLI-KC-LAPTFKGDFSLPGAYLRSKGLNRIGNLLVPNDNYCKFEDWIIPIFDEMLKE--QKEENVLWTPSKLLARLGKEIN-NESSYLYWAYKMNIPV	230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Hs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RYLVQHNMVDVLVTTAGGVEEDLI-KC-LAPTYLGEFSLRGKELRENGINRIGNLLVPNENYCKFEDWLMPILDQMVME--QNTEGVKWTPSKMIARLGKEIN-NPESVYYWAQKNHIPV	231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RYLVQHHMVDVIVTTTGGIEEDLI-KC-LADTFKGEFSLPGAELRSKGLNRIGNLLVPNDNYCKFEDWIIPIFDQMLEE--QKAKNVLWTPSKLIMRLGKEIN-NESSYLYWAYKNDIPV	233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1      CYLTQHRMVDVLVTTTGGIEEDFI-KC-LASTYKGKFSLPGADLRSKGLNRIGNLIVPNDNYIKFEDWIIPIFDQMLIE--QKTQNVLWTPSRMIARLGKEIN-NETSYLYWAYKNNIPV	229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2      CYLTQHRMVDVLVTTTGGIEEDFI-KC-LASTYKGKFSLPGADLRSKGLNRIGNLIVPNDNYIKFEDWIIPIFDQMLIE--QKTQNVLWTPSRMIARLGKEIN-NETSYLYWAYKNNIPV	229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sSpeY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APLIRNGFIDWMISTGANLYHDM-HFGLGFELFTGNPFLDDVKLRQEGTIRIYDIIFSYEVLLETDAFIRKILQGEAFQKRMGTAEFHYLLGKYVREVEKQLGVQHSCLLATAYEYGVPI	191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      * :: ::* :::* ..: .:          : *.    .  **     ** :  .  :   . :  :  * :            . :  .: : .     .    .    * :  :*: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 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dm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FVPAFSDSSAGFGLVYHQVKRPEAHVTIDSVADFRELTEI----KLKAGTTGLVMLGGGVPKNFAQDI-VVAAEVLGHRVEMHKYAIQITVADERDGGLSGSTLSEAQSWGKVDARL---	299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At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FCPGLTDGSLGDMLYFHSFRT--SGLIIDVVQDIRAMNGEAV--HANPKKTGMIILGGGLPKHHICNA--------NMMRNGADYAVFINTGQEFDGSDSGARPDEAVSWGKIRGSA--K	336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Hs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FSPALTDGSLGDMIFFHSYKN--PGLVLDIVEDLRLINTQAI--FA--KCTGMIILGGGVVKHHIANA--------NLMRNGADYAVYINTAQEFDGSDSGARPDEAVSWGKIRVDA--Q	335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FCPGLTDGSLGDMLYFHTFRN--PGLIVDVVQDIRAINSEAV--HANPRKTGMIILGGGLPKHHICNA--------NMMRNGADYAVFINTAQEFDGSDSGARPDEAVSWGKIRGSA--K	339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1      FCPSITDGSIGDMLYFHSVSNPGPGLVVDIVQDVIAMDNEAV--HASPQKTGIIILGGGLPKHHICNA--------NMMRNGADFAVFINTAQEYDGSDSGARPDEAVSWGKISSTG--K	337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2      FCPSITDGSIGDMLYFHSVSNPGPGLVVDIVQDVIAMDNEAV--HASPQKTGIIILGGGLPKHHICNA--------NMMRNGADFAVFINTAQEYDGSDSGARPDEAVSWGKISSTG--K	337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sSpeY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YTSSPGDSSIGMNVAALALEG--SQLVIDPSIDVNETAAIAYGARESEGKSAAVIIGGGSPKNFLLQTQPQIHEVLGLEERGHDYFIQFTDARPDTGGLSGATPAEAVSWGKIDPLELPN	309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indent="63500"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    :  .  *.* *  :           : :*   *.                :. :::*** *:.  :         .   .  .: : :. .    *. **:   ** ****:       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 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dm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SQMVFAEATLAFPLLASYVWHRAPARAKRRYAEL----FR----EK-----APA--------------------	340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At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TVKVYCDATIAFPLLVAETFATKRDQTCESKT------------------------------------------	368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Hs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PVKVYADASLVFPLLVAETFAQKMDAFMHEKN------ED----------------------------------	369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DHS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SVKVHCDATIAFPLLVAETFAAKREQSAEPSS------------------------------------------	371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1      AVKVHCDATIAFPLLVAETFAVKKEKASKVNG------F-----------------------------------	370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SvHSS2      AVKVHCDATIAFPLLVAETFAVKKEKASKVNG------F-----------------------------------	370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 err="1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CsSpeY</a:t>
              </a: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TIVCYTDSTIALPLVTAYVMNQCQPRPLKRLYDQREALYDKLQKDYLAAKDKPSVADGKS EEVATYPCGTPVKR	383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  <a:p>
              <a:pPr algn="l">
                <a:tabLst>
                  <a:tab pos="581660" algn="l"/>
                  <a:tab pos="1163320" algn="l"/>
                  <a:tab pos="1744980" algn="l"/>
                  <a:tab pos="2326640" algn="l"/>
                  <a:tab pos="2908300" algn="l"/>
                  <a:tab pos="3489960" algn="l"/>
                  <a:tab pos="4071620" algn="l"/>
                  <a:tab pos="4653280" algn="l"/>
                  <a:tab pos="5234940" algn="l"/>
                  <a:tab pos="5816600" algn="l"/>
                  <a:tab pos="6398260" algn="l"/>
                  <a:tab pos="6979920" algn="l"/>
                  <a:tab pos="7561580" algn="l"/>
                  <a:tab pos="8143240" algn="l"/>
                  <a:tab pos="8724900" algn="l"/>
                  <a:tab pos="9306560" algn="l"/>
                </a:tabLst>
              </a:pPr>
              <a:r>
                <a:rPr lang="en-US" altLang="ja-JP" sz="1400" kern="0" dirty="0">
                  <a:effectLst/>
                  <a:latin typeface="ＭＳ ゴシック" panose="020B0609070205080204" pitchFamily="49" charset="-128"/>
                  <a:ea typeface="游明朝" panose="02020400000000000000" pitchFamily="18" charset="-128"/>
                  <a:cs typeface="ＭＳ ゴシック" panose="020B0609070205080204" pitchFamily="49" charset="-128"/>
                </a:rPr>
                <a:t>                . ::::.:**:.: .         .                               </a:t>
              </a:r>
              <a:endParaRPr lang="ja-JP" altLang="ja-JP" sz="1400" kern="10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xmlns="" id="{B1192F34-8FDF-5881-FB84-17DD1F760C62}"/>
                </a:ext>
              </a:extLst>
            </p:cNvPr>
            <p:cNvSpPr/>
            <p:nvPr/>
          </p:nvSpPr>
          <p:spPr>
            <a:xfrm>
              <a:off x="13261863" y="1152402"/>
              <a:ext cx="92396" cy="1556388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cxnSp>
          <p:nvCxnSpPr>
            <p:cNvPr id="9" name="直線矢印コネクタ 8">
              <a:extLst>
                <a:ext uri="{FF2B5EF4-FFF2-40B4-BE49-F238E27FC236}">
                  <a16:creationId xmlns:a16="http://schemas.microsoft.com/office/drawing/2014/main" xmlns="" id="{A52F3E64-A00B-5670-31A7-6641574719D0}"/>
                </a:ext>
              </a:extLst>
            </p:cNvPr>
            <p:cNvCxnSpPr>
              <a:cxnSpLocks/>
            </p:cNvCxnSpPr>
            <p:nvPr/>
          </p:nvCxnSpPr>
          <p:spPr>
            <a:xfrm>
              <a:off x="13577428" y="4752739"/>
              <a:ext cx="0" cy="208067"/>
            </a:xfrm>
            <a:prstGeom prst="straightConnector1">
              <a:avLst/>
            </a:prstGeom>
            <a:ln w="3175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xmlns="" id="{09C04735-03E2-F408-7470-A74E3EC0CF2B}"/>
                </a:ext>
              </a:extLst>
            </p:cNvPr>
            <p:cNvSpPr/>
            <p:nvPr/>
          </p:nvSpPr>
          <p:spPr>
            <a:xfrm>
              <a:off x="5444084" y="3069644"/>
              <a:ext cx="92396" cy="1556388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xmlns="" id="{10430BB9-EA9F-FA30-9336-45B7EC84687F}"/>
                </a:ext>
              </a:extLst>
            </p:cNvPr>
            <p:cNvSpPr/>
            <p:nvPr/>
          </p:nvSpPr>
          <p:spPr>
            <a:xfrm>
              <a:off x="4383655" y="4975245"/>
              <a:ext cx="92396" cy="1556388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xmlns="" id="{F5EABE9E-77A7-4AAD-F2C8-A977553CBBD9}"/>
                </a:ext>
              </a:extLst>
            </p:cNvPr>
            <p:cNvSpPr/>
            <p:nvPr/>
          </p:nvSpPr>
          <p:spPr>
            <a:xfrm>
              <a:off x="13533535" y="4979203"/>
              <a:ext cx="92396" cy="1556388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274677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xmlns="" id="{3D6BD2C1-81C0-0A7B-1799-E394BDAD1C6E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221733311"/>
              </p:ext>
            </p:extLst>
          </p:nvPr>
        </p:nvGraphicFramePr>
        <p:xfrm>
          <a:off x="1894205" y="1921016"/>
          <a:ext cx="6335761" cy="43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xmlns="" id="{5B9DC6C9-BA92-B0BA-A712-0F8D8329D466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798151105"/>
              </p:ext>
            </p:extLst>
          </p:nvPr>
        </p:nvGraphicFramePr>
        <p:xfrm>
          <a:off x="9323108" y="1903924"/>
          <a:ext cx="6582109" cy="43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76E24051-39D7-17C5-F2AA-9CF8B89709B1}"/>
              </a:ext>
            </a:extLst>
          </p:cNvPr>
          <p:cNvSpPr txBox="1"/>
          <p:nvPr/>
        </p:nvSpPr>
        <p:spPr>
          <a:xfrm>
            <a:off x="1612087" y="953149"/>
            <a:ext cx="11222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8E16BDE4-1B2D-63EC-ACB4-E0B63E0EFFE2}"/>
              </a:ext>
            </a:extLst>
          </p:cNvPr>
          <p:cNvSpPr txBox="1"/>
          <p:nvPr/>
        </p:nvSpPr>
        <p:spPr>
          <a:xfrm>
            <a:off x="9240762" y="953149"/>
            <a:ext cx="11222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xmlns="" id="{CF098A5C-D99D-1F00-72CE-9CF5A828E36B}"/>
              </a:ext>
            </a:extLst>
          </p:cNvPr>
          <p:cNvSpPr/>
          <p:nvPr/>
        </p:nvSpPr>
        <p:spPr>
          <a:xfrm>
            <a:off x="2392686" y="5883784"/>
            <a:ext cx="344906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xmlns="" id="{710E48EF-F8DC-4EF8-60CA-74CC08BA4474}"/>
              </a:ext>
            </a:extLst>
          </p:cNvPr>
          <p:cNvSpPr/>
          <p:nvPr/>
        </p:nvSpPr>
        <p:spPr>
          <a:xfrm>
            <a:off x="3371253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BD1BA5D8-F6FD-52F1-ABFD-2270C3A4CF42}"/>
              </a:ext>
            </a:extLst>
          </p:cNvPr>
          <p:cNvSpPr/>
          <p:nvPr/>
        </p:nvSpPr>
        <p:spPr>
          <a:xfrm>
            <a:off x="4349820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xmlns="" id="{E24C09F5-7838-11F9-F3C9-DD3D9C9A61BF}"/>
              </a:ext>
            </a:extLst>
          </p:cNvPr>
          <p:cNvSpPr/>
          <p:nvPr/>
        </p:nvSpPr>
        <p:spPr>
          <a:xfrm>
            <a:off x="5328387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FD85EE45-400B-D187-AEE3-6972EE42E2E2}"/>
              </a:ext>
            </a:extLst>
          </p:cNvPr>
          <p:cNvSpPr/>
          <p:nvPr/>
        </p:nvSpPr>
        <p:spPr>
          <a:xfrm>
            <a:off x="6306954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xmlns="" id="{C3B3340C-0943-D915-EBB9-4B7950FD377E}"/>
              </a:ext>
            </a:extLst>
          </p:cNvPr>
          <p:cNvSpPr/>
          <p:nvPr/>
        </p:nvSpPr>
        <p:spPr>
          <a:xfrm>
            <a:off x="7285521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xmlns="" id="{A159817F-B393-B537-3198-6A7806D94D3C}"/>
              </a:ext>
            </a:extLst>
          </p:cNvPr>
          <p:cNvSpPr/>
          <p:nvPr/>
        </p:nvSpPr>
        <p:spPr>
          <a:xfrm>
            <a:off x="9799832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xmlns="" id="{D7B03D53-5984-3F73-0862-8737A461F670}"/>
              </a:ext>
            </a:extLst>
          </p:cNvPr>
          <p:cNvSpPr/>
          <p:nvPr/>
        </p:nvSpPr>
        <p:spPr>
          <a:xfrm>
            <a:off x="10772968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xmlns="" id="{CF82C42E-9998-EB6C-D6E4-5C1C95B45FBE}"/>
              </a:ext>
            </a:extLst>
          </p:cNvPr>
          <p:cNvSpPr/>
          <p:nvPr/>
        </p:nvSpPr>
        <p:spPr>
          <a:xfrm>
            <a:off x="11842357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xmlns="" id="{622919D8-DC9E-721F-A5CC-49E8BE0968CB}"/>
              </a:ext>
            </a:extLst>
          </p:cNvPr>
          <p:cNvSpPr/>
          <p:nvPr/>
        </p:nvSpPr>
        <p:spPr>
          <a:xfrm>
            <a:off x="12852524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xmlns="" id="{EEF1EE1E-0F94-C4B8-45EA-D15D8CAF2013}"/>
              </a:ext>
            </a:extLst>
          </p:cNvPr>
          <p:cNvSpPr/>
          <p:nvPr/>
        </p:nvSpPr>
        <p:spPr>
          <a:xfrm>
            <a:off x="13884882" y="5883784"/>
            <a:ext cx="425117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xmlns="" id="{C585A030-356B-942D-4765-AE691855E8A0}"/>
              </a:ext>
            </a:extLst>
          </p:cNvPr>
          <p:cNvSpPr/>
          <p:nvPr/>
        </p:nvSpPr>
        <p:spPr>
          <a:xfrm>
            <a:off x="14917240" y="5883784"/>
            <a:ext cx="505026" cy="2566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E0D44E19-68F1-A0C7-3D6D-C83C46435AC6}"/>
              </a:ext>
            </a:extLst>
          </p:cNvPr>
          <p:cNvSpPr txBox="1"/>
          <p:nvPr/>
        </p:nvSpPr>
        <p:spPr>
          <a:xfrm rot="16200000">
            <a:off x="94032" y="3658982"/>
            <a:ext cx="31106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Relative activity (%)</a:t>
            </a:r>
            <a:endParaRPr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047AE9F2-1725-BAB1-72F3-E757AB992E85}"/>
              </a:ext>
            </a:extLst>
          </p:cNvPr>
          <p:cNvSpPr txBox="1"/>
          <p:nvPr/>
        </p:nvSpPr>
        <p:spPr>
          <a:xfrm>
            <a:off x="11295313" y="6226022"/>
            <a:ext cx="28249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pH</a:t>
            </a:r>
            <a:endParaRPr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ABFB9CA5-30CE-EF2B-1535-B2A06AC8C015}"/>
              </a:ext>
            </a:extLst>
          </p:cNvPr>
          <p:cNvSpPr txBox="1"/>
          <p:nvPr/>
        </p:nvSpPr>
        <p:spPr>
          <a:xfrm rot="16200000">
            <a:off x="7580201" y="3658982"/>
            <a:ext cx="31106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Relative activity (%)</a:t>
            </a:r>
            <a:endParaRPr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87EDD09C-81AD-279E-3BDB-E9C1CCE5B300}"/>
              </a:ext>
            </a:extLst>
          </p:cNvPr>
          <p:cNvSpPr txBox="1"/>
          <p:nvPr/>
        </p:nvSpPr>
        <p:spPr>
          <a:xfrm>
            <a:off x="2760994" y="6226022"/>
            <a:ext cx="494964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emperature (</a:t>
            </a:r>
            <a:r>
              <a:rPr lang="en-US" altLang="ja-JP" sz="24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xmlns="" id="{8F28732C-D540-3112-FB3A-DC58925ED977}"/>
              </a:ext>
            </a:extLst>
          </p:cNvPr>
          <p:cNvCxnSpPr>
            <a:cxnSpLocks/>
          </p:cNvCxnSpPr>
          <p:nvPr/>
        </p:nvCxnSpPr>
        <p:spPr>
          <a:xfrm>
            <a:off x="3043776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xmlns="" id="{500CE806-D77C-0314-DCD3-50847E44FAD4}"/>
              </a:ext>
            </a:extLst>
          </p:cNvPr>
          <p:cNvCxnSpPr>
            <a:cxnSpLocks/>
          </p:cNvCxnSpPr>
          <p:nvPr/>
        </p:nvCxnSpPr>
        <p:spPr>
          <a:xfrm>
            <a:off x="4030083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xmlns="" id="{EF019F2F-8DE1-7FA0-E938-C086851E1772}"/>
              </a:ext>
            </a:extLst>
          </p:cNvPr>
          <p:cNvCxnSpPr>
            <a:cxnSpLocks/>
          </p:cNvCxnSpPr>
          <p:nvPr/>
        </p:nvCxnSpPr>
        <p:spPr>
          <a:xfrm>
            <a:off x="5013170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xmlns="" id="{0058DE63-B083-D5F5-F416-64CC0747E086}"/>
              </a:ext>
            </a:extLst>
          </p:cNvPr>
          <p:cNvCxnSpPr>
            <a:cxnSpLocks/>
          </p:cNvCxnSpPr>
          <p:nvPr/>
        </p:nvCxnSpPr>
        <p:spPr>
          <a:xfrm>
            <a:off x="5996257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xmlns="" id="{9B39BB3B-DED0-0001-9479-2FB3E3D0CCA1}"/>
              </a:ext>
            </a:extLst>
          </p:cNvPr>
          <p:cNvCxnSpPr>
            <a:cxnSpLocks/>
          </p:cNvCxnSpPr>
          <p:nvPr/>
        </p:nvCxnSpPr>
        <p:spPr>
          <a:xfrm>
            <a:off x="6979344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xmlns="" id="{2B23EA39-08BB-81C2-F632-2588F8787177}"/>
              </a:ext>
            </a:extLst>
          </p:cNvPr>
          <p:cNvCxnSpPr>
            <a:cxnSpLocks/>
          </p:cNvCxnSpPr>
          <p:nvPr/>
        </p:nvCxnSpPr>
        <p:spPr>
          <a:xfrm>
            <a:off x="10496349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xmlns="" id="{0AFF3B8C-5BEC-8E43-CDEF-86CE68296011}"/>
              </a:ext>
            </a:extLst>
          </p:cNvPr>
          <p:cNvCxnSpPr>
            <a:cxnSpLocks/>
          </p:cNvCxnSpPr>
          <p:nvPr/>
        </p:nvCxnSpPr>
        <p:spPr>
          <a:xfrm>
            <a:off x="11524512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xmlns="" id="{E3499233-459B-B553-8CEA-3AB6AA6B53A6}"/>
              </a:ext>
            </a:extLst>
          </p:cNvPr>
          <p:cNvCxnSpPr>
            <a:cxnSpLocks/>
          </p:cNvCxnSpPr>
          <p:nvPr/>
        </p:nvCxnSpPr>
        <p:spPr>
          <a:xfrm>
            <a:off x="12552675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C4DBC72B-2279-54A6-D56D-A45A0824A593}"/>
              </a:ext>
            </a:extLst>
          </p:cNvPr>
          <p:cNvCxnSpPr>
            <a:cxnSpLocks/>
          </p:cNvCxnSpPr>
          <p:nvPr/>
        </p:nvCxnSpPr>
        <p:spPr>
          <a:xfrm>
            <a:off x="13580838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xmlns="" id="{42207085-B6BB-11F9-1FB7-89A8BD2725FD}"/>
              </a:ext>
            </a:extLst>
          </p:cNvPr>
          <p:cNvCxnSpPr>
            <a:cxnSpLocks/>
          </p:cNvCxnSpPr>
          <p:nvPr/>
        </p:nvCxnSpPr>
        <p:spPr>
          <a:xfrm>
            <a:off x="14609001" y="5682731"/>
            <a:ext cx="0" cy="839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E0EAE44F-F8FF-5948-E034-2270FB2783DE}"/>
              </a:ext>
            </a:extLst>
          </p:cNvPr>
          <p:cNvSpPr txBox="1"/>
          <p:nvPr/>
        </p:nvSpPr>
        <p:spPr>
          <a:xfrm>
            <a:off x="1800477" y="6971368"/>
            <a:ext cx="1418134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ja-JP" sz="1800" b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 and temperature dependency of the enzymatic activity of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dmS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 The reactions were measured as described in Materials and Methods.  (A) Temperature dependency.  The reaction was performed in Tris-HCl (pH 8.5).  (B) pH dependency.  Buffers used were sodium phosphate (pH 6.0 – 8.0), Tris-HCl (pH 8.0 – 9.0), and glycine-NaOH (pH 9.0 – 10.5).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6411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ネックレス, 挿絵, 花 が含まれている画像&#10;&#10;自動的に生成された説明">
            <a:extLst>
              <a:ext uri="{FF2B5EF4-FFF2-40B4-BE49-F238E27FC236}">
                <a16:creationId xmlns:a16="http://schemas.microsoft.com/office/drawing/2014/main" xmlns="" id="{8DEFFD54-57D0-61FC-B3E0-E4B75C988D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4302" y="2053086"/>
            <a:ext cx="7532510" cy="8615026"/>
          </a:xfrm>
          <a:prstGeom prst="rect">
            <a:avLst/>
          </a:prstGeom>
        </p:spPr>
      </p:pic>
      <p:pic>
        <p:nvPicPr>
          <p:cNvPr id="7" name="図 6" descr="挿絵 が含まれている画像&#10;&#10;自動的に生成された説明">
            <a:extLst>
              <a:ext uri="{FF2B5EF4-FFF2-40B4-BE49-F238E27FC236}">
                <a16:creationId xmlns:a16="http://schemas.microsoft.com/office/drawing/2014/main" xmlns="" id="{BB2590CA-ED9F-3F7A-048E-626ADB768F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83427" y="-2003345"/>
            <a:ext cx="7532510" cy="8615026"/>
          </a:xfrm>
          <a:prstGeom prst="rect">
            <a:avLst/>
          </a:prstGeom>
        </p:spPr>
      </p:pic>
      <p:pic>
        <p:nvPicPr>
          <p:cNvPr id="16" name="図 15" descr="ネックレス, 光 が含まれている画像&#10;&#10;自動的に生成された説明">
            <a:extLst>
              <a:ext uri="{FF2B5EF4-FFF2-40B4-BE49-F238E27FC236}">
                <a16:creationId xmlns:a16="http://schemas.microsoft.com/office/drawing/2014/main" xmlns="" id="{845F2A2C-3A87-35DB-DEAF-4D9D6B3A63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48759" y="2023106"/>
            <a:ext cx="7532510" cy="8615026"/>
          </a:xfrm>
          <a:prstGeom prst="rect">
            <a:avLst/>
          </a:prstGeom>
        </p:spPr>
      </p:pic>
      <p:pic>
        <p:nvPicPr>
          <p:cNvPr id="18" name="図 17" descr="花火の写真と文字の加工写真&#10;&#10;中程度の精度で自動的に生成された説明">
            <a:extLst>
              <a:ext uri="{FF2B5EF4-FFF2-40B4-BE49-F238E27FC236}">
                <a16:creationId xmlns:a16="http://schemas.microsoft.com/office/drawing/2014/main" xmlns="" id="{3525CA66-821B-408B-B66D-494F62E945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25028" y="-1688553"/>
            <a:ext cx="7532510" cy="8615026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BD41954A-3912-9602-BD46-5C1C528BBCCD}"/>
              </a:ext>
            </a:extLst>
          </p:cNvPr>
          <p:cNvSpPr txBox="1"/>
          <p:nvPr/>
        </p:nvSpPr>
        <p:spPr>
          <a:xfrm>
            <a:off x="3143269" y="294538"/>
            <a:ext cx="1122216" cy="584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19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31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841B9E41-E427-DEF6-1017-29D29559F846}"/>
              </a:ext>
            </a:extLst>
          </p:cNvPr>
          <p:cNvSpPr txBox="1"/>
          <p:nvPr/>
        </p:nvSpPr>
        <p:spPr>
          <a:xfrm>
            <a:off x="8833033" y="294538"/>
            <a:ext cx="1122216" cy="584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19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1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95286DAC-8425-A81E-02D5-95F35E733FFE}"/>
              </a:ext>
            </a:extLst>
          </p:cNvPr>
          <p:cNvSpPr txBox="1"/>
          <p:nvPr/>
        </p:nvSpPr>
        <p:spPr>
          <a:xfrm>
            <a:off x="3143269" y="4020703"/>
            <a:ext cx="1122216" cy="584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199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31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6BCFD021-DEFD-8422-8DE2-DC83AFC67C57}"/>
              </a:ext>
            </a:extLst>
          </p:cNvPr>
          <p:cNvSpPr txBox="1"/>
          <p:nvPr/>
        </p:nvSpPr>
        <p:spPr>
          <a:xfrm>
            <a:off x="8833033" y="4020703"/>
            <a:ext cx="1122216" cy="584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199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319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501722E7-E5EC-C847-1DCC-B3AF94CC93EA}"/>
              </a:ext>
            </a:extLst>
          </p:cNvPr>
          <p:cNvSpPr txBox="1"/>
          <p:nvPr/>
        </p:nvSpPr>
        <p:spPr>
          <a:xfrm>
            <a:off x="882768" y="7765741"/>
            <a:ext cx="15844603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ja-JP" sz="18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Overall structures of monomers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sDH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and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vHS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 (A) An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lphaFold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2 prediction model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</a:t>
            </a:r>
            <a:r>
              <a:rPr lang="en-US" altLang="ja-JP" sz="1800" dirty="0">
                <a:effectLst/>
                <a:latin typeface="Symbol" pitchFamily="2" charset="2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-Helices and </a:t>
            </a:r>
            <a:r>
              <a:rPr lang="en-US" altLang="ja-JP" sz="1800" dirty="0">
                <a:effectLst/>
                <a:latin typeface="Symbol" pitchFamily="2" charset="2"/>
                <a:ea typeface="游明朝" panose="02020400000000000000" pitchFamily="18" charset="-128"/>
                <a:cs typeface="Times New Roman" panose="02020603050405020304" pitchFamily="18" charset="0"/>
              </a:rPr>
              <a:t>b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-strands are shown in cyan and magenta, respectively.  (B) A crystal structure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sDH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complexed with NAD and spermidine (PDB ID 6XXJ chain A).  NAD and spermidine molecules are shown as stick and sphere models, respectively.  (C) A crystal structure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vHS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complexed with NAD and putrescine (PDB ID 4TVB). NAD and putrescine molecules are shown as stick and sphere models, respectively.  (D) A superposition of structures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sDH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showing that they are very similar with a RMSD of 1.15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Å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for 220 C</a:t>
            </a:r>
            <a:r>
              <a:rPr lang="en-US" altLang="ja-JP" sz="1800" dirty="0">
                <a:effectLst/>
                <a:latin typeface="Symbol" pitchFamily="2" charset="2"/>
                <a:ea typeface="游明朝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toms, with N- and C-terminal regions being largely diverged.  Note that the structure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vHS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is entirely different from those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sDH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in spite that they commonly possess nucleotide-binding motif structures (so-called a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Rossmann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fold)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32188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:a16="http://schemas.microsoft.com/office/drawing/2014/main" xmlns="" id="{CF236CA2-0E63-FEFF-0F7F-3C73FD3DF7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0778" y="1009014"/>
            <a:ext cx="10748582" cy="7165721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95795A86-4BA5-D570-F593-5B1C6017DD72}"/>
              </a:ext>
            </a:extLst>
          </p:cNvPr>
          <p:cNvSpPr txBox="1"/>
          <p:nvPr/>
        </p:nvSpPr>
        <p:spPr>
          <a:xfrm>
            <a:off x="8498006" y="1010377"/>
            <a:ext cx="11222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11F1E141-8510-F290-D5FC-8360A7760756}"/>
              </a:ext>
            </a:extLst>
          </p:cNvPr>
          <p:cNvSpPr txBox="1"/>
          <p:nvPr/>
        </p:nvSpPr>
        <p:spPr>
          <a:xfrm>
            <a:off x="10057538" y="1010377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09CF0C5B-9695-A95A-CDA1-50E032FCFE3D}"/>
              </a:ext>
            </a:extLst>
          </p:cNvPr>
          <p:cNvSpPr txBox="1"/>
          <p:nvPr/>
        </p:nvSpPr>
        <p:spPr>
          <a:xfrm>
            <a:off x="10728269" y="1010377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FD03E9BB-45DA-8F97-A698-6FC0CB1D5D18}"/>
              </a:ext>
            </a:extLst>
          </p:cNvPr>
          <p:cNvSpPr txBox="1"/>
          <p:nvPr/>
        </p:nvSpPr>
        <p:spPr>
          <a:xfrm>
            <a:off x="11370825" y="1010377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5C4EB442-3E53-D3AC-C091-45D5DD401A55}"/>
              </a:ext>
            </a:extLst>
          </p:cNvPr>
          <p:cNvSpPr txBox="1"/>
          <p:nvPr/>
        </p:nvSpPr>
        <p:spPr>
          <a:xfrm>
            <a:off x="9449745" y="1010377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0C865401-1EC9-7AF2-6A6B-0CA99AB4D02C}"/>
              </a:ext>
            </a:extLst>
          </p:cNvPr>
          <p:cNvSpPr txBox="1"/>
          <p:nvPr/>
        </p:nvSpPr>
        <p:spPr>
          <a:xfrm>
            <a:off x="8827472" y="3277030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A51AEFFB-5DA7-6A42-D1D6-3C35F6C43A39}"/>
              </a:ext>
            </a:extLst>
          </p:cNvPr>
          <p:cNvSpPr txBox="1"/>
          <p:nvPr/>
        </p:nvSpPr>
        <p:spPr>
          <a:xfrm>
            <a:off x="8827472" y="3907220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0855C52D-D669-3283-0697-C1413790234A}"/>
              </a:ext>
            </a:extLst>
          </p:cNvPr>
          <p:cNvSpPr txBox="1"/>
          <p:nvPr/>
        </p:nvSpPr>
        <p:spPr>
          <a:xfrm>
            <a:off x="8827472" y="4588270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3F09F227-F67E-27D7-4C62-2A741B74C820}"/>
              </a:ext>
            </a:extLst>
          </p:cNvPr>
          <p:cNvSpPr txBox="1"/>
          <p:nvPr/>
        </p:nvSpPr>
        <p:spPr>
          <a:xfrm>
            <a:off x="8827472" y="2834804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A4690F96-0331-A2EC-BB40-A895484E81BE}"/>
              </a:ext>
            </a:extLst>
          </p:cNvPr>
          <p:cNvSpPr txBox="1"/>
          <p:nvPr/>
        </p:nvSpPr>
        <p:spPr>
          <a:xfrm>
            <a:off x="8823632" y="2408803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7DDE24F2-6ED0-012E-5175-AA3FE5A095B9}"/>
              </a:ext>
            </a:extLst>
          </p:cNvPr>
          <p:cNvSpPr txBox="1"/>
          <p:nvPr/>
        </p:nvSpPr>
        <p:spPr>
          <a:xfrm>
            <a:off x="8823632" y="5925680"/>
            <a:ext cx="5316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xmlns="" id="{F1DF4677-870F-A77C-065F-20479CB5DBF3}"/>
              </a:ext>
            </a:extLst>
          </p:cNvPr>
          <p:cNvSpPr/>
          <p:nvPr/>
        </p:nvSpPr>
        <p:spPr>
          <a:xfrm rot="10800000">
            <a:off x="13605804" y="3709759"/>
            <a:ext cx="432000" cy="13834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106555" y="3515417"/>
            <a:ext cx="120898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/>
              <a:t>38 </a:t>
            </a:r>
            <a:r>
              <a:rPr kumimoji="1" lang="en-US" altLang="ja-JP" sz="2800" b="1" dirty="0" err="1"/>
              <a:t>kDa</a:t>
            </a:r>
            <a:endParaRPr kumimoji="1" lang="ja-JP" altLang="en-US" sz="2800" b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12B72CF9-F8B1-27A6-3C88-CAFF0481B6A7}"/>
              </a:ext>
            </a:extLst>
          </p:cNvPr>
          <p:cNvSpPr txBox="1"/>
          <p:nvPr/>
        </p:nvSpPr>
        <p:spPr>
          <a:xfrm>
            <a:off x="2527737" y="8200626"/>
            <a:ext cx="1312679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</a:t>
            </a:r>
            <a:r>
              <a:rPr lang="ja-JP" altLang="ja-JP" sz="18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DS-PAGE analysis of purified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 Protein bands were stained with Coomassie Brilliant Blue R-250.  Lane M, protein marker Broad Range (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ermo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Scientific).  Lane 1, </a:t>
            </a:r>
            <a:r>
              <a:rPr lang="en-US" altLang="ja-JP" sz="18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E. coli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BL21(DE3) crude extract after induction with 1 mM IPTG.  Lane 2, heat treatment.  Lane 3,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CdmS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purified by TOYOPEARL Butyl 650M column.</a:t>
            </a:r>
            <a:r>
              <a:rPr lang="ja-JP" altLang="ja-JP" dirty="0">
                <a:effectLst/>
              </a:rPr>
              <a:t> 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7140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31</TotalTime>
  <Words>461</Words>
  <Application>Microsoft Office PowerPoint</Application>
  <PresentationFormat>Custom</PresentationFormat>
  <Paragraphs>69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4" baseType="lpstr">
      <vt:lpstr>ＭＳ ゴシック</vt:lpstr>
      <vt:lpstr>ＭＳ Ｐゴシック</vt:lpstr>
      <vt:lpstr>游ゴシック</vt:lpstr>
      <vt:lpstr>Arial</vt:lpstr>
      <vt:lpstr>Calibri</vt:lpstr>
      <vt:lpstr>Calibri Light</vt:lpstr>
      <vt:lpstr>Symbol</vt:lpstr>
      <vt:lpstr>Times New Roman</vt:lpstr>
      <vt:lpstr>游明朝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kamoto</dc:creator>
  <cp:lastModifiedBy>Thivya Ramesh</cp:lastModifiedBy>
  <cp:revision>702</cp:revision>
  <cp:lastPrinted>2023-07-12T00:59:42Z</cp:lastPrinted>
  <dcterms:created xsi:type="dcterms:W3CDTF">2019-02-06T07:42:39Z</dcterms:created>
  <dcterms:modified xsi:type="dcterms:W3CDTF">2024-03-27T12:10:37Z</dcterms:modified>
</cp:coreProperties>
</file>